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75" d="100"/>
          <a:sy n="75" d="100"/>
        </p:scale>
        <p:origin x="327" y="-150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\Documents\Write-ups\_Manuscripts\ABA%20suppresses%20WGE%20elicitation%20of%20glyceollins\Extras\Fig3\ABA%20and%20WGE%20HRs%20From%20MYB29A2%20file%20Fig3C%20Supplem%20Exp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$3</c:f>
              <c:strCache>
                <c:ptCount val="1"/>
                <c:pt idx="0">
                  <c:v>p35S::vector+H2O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2!$B$1:$E$1</c:f>
              <c:strCache>
                <c:ptCount val="4"/>
                <c:pt idx="0">
                  <c:v>Glyceollin I</c:v>
                </c:pt>
                <c:pt idx="1">
                  <c:v>Glyceollin II</c:v>
                </c:pt>
                <c:pt idx="2">
                  <c:v>Glyceollin III</c:v>
                </c:pt>
                <c:pt idx="3">
                  <c:v>Total glyceollins</c:v>
                </c:pt>
              </c:strCache>
            </c:strRef>
          </c:cat>
          <c:val>
            <c:numRef>
              <c:f>Sheet2!$B$3:$E$3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49A-4B0C-8EDA-92DC782CFFC8}"/>
            </c:ext>
          </c:extLst>
        </c:ser>
        <c:ser>
          <c:idx val="1"/>
          <c:order val="1"/>
          <c:tx>
            <c:strRef>
              <c:f>Sheet2!$A$9</c:f>
              <c:strCache>
                <c:ptCount val="1"/>
                <c:pt idx="0">
                  <c:v>p35S::vector+AB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val>
            <c:numRef>
              <c:f>Sheet2!$B$9:$E$9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49A-4B0C-8EDA-92DC782CFFC8}"/>
            </c:ext>
          </c:extLst>
        </c:ser>
        <c:ser>
          <c:idx val="2"/>
          <c:order val="2"/>
          <c:tx>
            <c:strRef>
              <c:f>Sheet2!$A$14</c:f>
              <c:strCache>
                <c:ptCount val="1"/>
                <c:pt idx="0">
                  <c:v>p35S::vector+WGE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B$15:$E$15</c:f>
                <c:numCache>
                  <c:formatCode>General</c:formatCode>
                  <c:ptCount val="4"/>
                  <c:pt idx="0">
                    <c:v>43268.725532927769</c:v>
                  </c:pt>
                  <c:pt idx="1">
                    <c:v>11121.363463652429</c:v>
                  </c:pt>
                  <c:pt idx="2">
                    <c:v>4908.8546332139022</c:v>
                  </c:pt>
                  <c:pt idx="3">
                    <c:v>56728.165301142646</c:v>
                  </c:pt>
                </c:numCache>
              </c:numRef>
            </c:plus>
            <c:minus>
              <c:numRef>
                <c:f>Sheet2!$B$15:$E$15</c:f>
                <c:numCache>
                  <c:formatCode>General</c:formatCode>
                  <c:ptCount val="4"/>
                  <c:pt idx="0">
                    <c:v>43268.725532927769</c:v>
                  </c:pt>
                  <c:pt idx="1">
                    <c:v>11121.363463652429</c:v>
                  </c:pt>
                  <c:pt idx="2">
                    <c:v>4908.8546332139022</c:v>
                  </c:pt>
                  <c:pt idx="3">
                    <c:v>56728.16530114264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2!$B$14:$E$14</c:f>
              <c:numCache>
                <c:formatCode>General</c:formatCode>
                <c:ptCount val="4"/>
                <c:pt idx="0">
                  <c:v>442112.29500000004</c:v>
                </c:pt>
                <c:pt idx="1">
                  <c:v>97664.09</c:v>
                </c:pt>
                <c:pt idx="2">
                  <c:v>81794.569999999992</c:v>
                </c:pt>
                <c:pt idx="3">
                  <c:v>621570.954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49A-4B0C-8EDA-92DC782CFFC8}"/>
            </c:ext>
          </c:extLst>
        </c:ser>
        <c:ser>
          <c:idx val="3"/>
          <c:order val="3"/>
          <c:tx>
            <c:strRef>
              <c:f>Sheet2!$A$19</c:f>
              <c:strCache>
                <c:ptCount val="1"/>
                <c:pt idx="0">
                  <c:v>p35S::vector+WGE+AB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B$20:$E$20</c:f>
                <c:numCache>
                  <c:formatCode>General</c:formatCode>
                  <c:ptCount val="4"/>
                  <c:pt idx="0">
                    <c:v>16365.637700947933</c:v>
                  </c:pt>
                  <c:pt idx="1">
                    <c:v>9391.1130040866301</c:v>
                  </c:pt>
                  <c:pt idx="2">
                    <c:v>9518.5099039069664</c:v>
                  </c:pt>
                  <c:pt idx="3">
                    <c:v>33901.66661219536</c:v>
                  </c:pt>
                </c:numCache>
              </c:numRef>
            </c:plus>
            <c:minus>
              <c:numRef>
                <c:f>Sheet2!$B$20:$E$20</c:f>
                <c:numCache>
                  <c:formatCode>General</c:formatCode>
                  <c:ptCount val="4"/>
                  <c:pt idx="0">
                    <c:v>16365.637700947933</c:v>
                  </c:pt>
                  <c:pt idx="1">
                    <c:v>9391.1130040866301</c:v>
                  </c:pt>
                  <c:pt idx="2">
                    <c:v>9518.5099039069664</c:v>
                  </c:pt>
                  <c:pt idx="3">
                    <c:v>33901.6666121953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2!$B$19:$E$19</c:f>
              <c:numCache>
                <c:formatCode>General</c:formatCode>
                <c:ptCount val="4"/>
                <c:pt idx="0">
                  <c:v>151406</c:v>
                </c:pt>
                <c:pt idx="1">
                  <c:v>44476.455000000002</c:v>
                </c:pt>
                <c:pt idx="2">
                  <c:v>49452.62</c:v>
                </c:pt>
                <c:pt idx="3">
                  <c:v>245335.074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49A-4B0C-8EDA-92DC782CFF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91782280"/>
        <c:axId val="891782608"/>
      </c:barChart>
      <c:catAx>
        <c:axId val="891782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891782608"/>
        <c:crosses val="autoZero"/>
        <c:auto val="1"/>
        <c:lblAlgn val="ctr"/>
        <c:lblOffset val="100"/>
        <c:noMultiLvlLbl val="0"/>
      </c:catAx>
      <c:valAx>
        <c:axId val="8917826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Absorbance A283nm (mAU gt</a:t>
                </a:r>
                <a:r>
                  <a:rPr lang="en-US" baseline="30000"/>
                  <a:t>1-</a:t>
                </a:r>
                <a:r>
                  <a:rPr lang="en-US"/>
                  <a:t>)</a:t>
                </a:r>
              </a:p>
            </c:rich>
          </c:tx>
          <c:layout>
            <c:manualLayout>
              <c:xMode val="edge"/>
              <c:yMode val="edge"/>
              <c:x val="2.2222222222222223E-2"/>
              <c:y val="0.1593558617672790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8917822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37417541557305339"/>
          <c:y val="6.134149897929423E-2"/>
          <c:w val="0.28971347331583552"/>
          <c:h val="0.24768737241178185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ECEB0-78F0-4417-9952-8AF795B09B5E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B11CD-9A36-46F1-99D6-ED797F99C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471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ECEB0-78F0-4417-9952-8AF795B09B5E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B11CD-9A36-46F1-99D6-ED797F99C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00457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ECEB0-78F0-4417-9952-8AF795B09B5E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B11CD-9A36-46F1-99D6-ED797F99C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873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ECEB0-78F0-4417-9952-8AF795B09B5E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B11CD-9A36-46F1-99D6-ED797F99C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0491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ECEB0-78F0-4417-9952-8AF795B09B5E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B11CD-9A36-46F1-99D6-ED797F99C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480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ECEB0-78F0-4417-9952-8AF795B09B5E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B11CD-9A36-46F1-99D6-ED797F99C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621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ECEB0-78F0-4417-9952-8AF795B09B5E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B11CD-9A36-46F1-99D6-ED797F99C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244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ECEB0-78F0-4417-9952-8AF795B09B5E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B11CD-9A36-46F1-99D6-ED797F99C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36854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ECEB0-78F0-4417-9952-8AF795B09B5E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B11CD-9A36-46F1-99D6-ED797F99C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33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ECEB0-78F0-4417-9952-8AF795B09B5E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B11CD-9A36-46F1-99D6-ED797F99C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51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ECEB0-78F0-4417-9952-8AF795B09B5E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B11CD-9A36-46F1-99D6-ED797F99C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58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CECEB0-78F0-4417-9952-8AF795B09B5E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BB11CD-9A36-46F1-99D6-ED797F99C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644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5ACF1450-9798-4C42-9D7E-384EEE63B7A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1587069"/>
              </p:ext>
            </p:extLst>
          </p:nvPr>
        </p:nvGraphicFramePr>
        <p:xfrm>
          <a:off x="1412631" y="2625969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693AB494-7F46-440F-90C1-22ADCDA052B2}"/>
              </a:ext>
            </a:extLst>
          </p:cNvPr>
          <p:cNvSpPr txBox="1"/>
          <p:nvPr/>
        </p:nvSpPr>
        <p:spPr>
          <a:xfrm>
            <a:off x="2625969" y="3434862"/>
            <a:ext cx="269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D0BD6E4-EE01-440A-8E15-D3AD2136483D}"/>
              </a:ext>
            </a:extLst>
          </p:cNvPr>
          <p:cNvSpPr txBox="1"/>
          <p:nvPr/>
        </p:nvSpPr>
        <p:spPr>
          <a:xfrm>
            <a:off x="3528646" y="4536831"/>
            <a:ext cx="269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FBAE97E-992C-486A-892F-B147F05BBAFF}"/>
              </a:ext>
            </a:extLst>
          </p:cNvPr>
          <p:cNvSpPr txBox="1"/>
          <p:nvPr/>
        </p:nvSpPr>
        <p:spPr>
          <a:xfrm>
            <a:off x="4454769" y="4607169"/>
            <a:ext cx="269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51E702A-90A1-4B52-91E9-FB0819D18E0B}"/>
              </a:ext>
            </a:extLst>
          </p:cNvPr>
          <p:cNvSpPr txBox="1"/>
          <p:nvPr/>
        </p:nvSpPr>
        <p:spPr>
          <a:xfrm>
            <a:off x="5345723" y="2872153"/>
            <a:ext cx="269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83C6524-C614-48F8-9487-1CC2DCBE0CE8}"/>
              </a:ext>
            </a:extLst>
          </p:cNvPr>
          <p:cNvSpPr txBox="1"/>
          <p:nvPr/>
        </p:nvSpPr>
        <p:spPr>
          <a:xfrm>
            <a:off x="5521569" y="3985845"/>
            <a:ext cx="269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8E6F3FC-A793-47F6-B600-5F14F75290E7}"/>
              </a:ext>
            </a:extLst>
          </p:cNvPr>
          <p:cNvSpPr txBox="1"/>
          <p:nvPr/>
        </p:nvSpPr>
        <p:spPr>
          <a:xfrm>
            <a:off x="4607169" y="4689229"/>
            <a:ext cx="269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FCD8B52-9E99-4075-89BE-A362FD87D6DB}"/>
              </a:ext>
            </a:extLst>
          </p:cNvPr>
          <p:cNvSpPr txBox="1"/>
          <p:nvPr/>
        </p:nvSpPr>
        <p:spPr>
          <a:xfrm>
            <a:off x="3704492" y="4736121"/>
            <a:ext cx="269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3C98544-270C-4F47-818B-64EB8A125831}"/>
              </a:ext>
            </a:extLst>
          </p:cNvPr>
          <p:cNvSpPr txBox="1"/>
          <p:nvPr/>
        </p:nvSpPr>
        <p:spPr>
          <a:xfrm>
            <a:off x="2801815" y="4384429"/>
            <a:ext cx="269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93C1863-0D5C-466D-B808-70A4CCC423E6}"/>
              </a:ext>
            </a:extLst>
          </p:cNvPr>
          <p:cNvSpPr txBox="1"/>
          <p:nvPr/>
        </p:nvSpPr>
        <p:spPr>
          <a:xfrm>
            <a:off x="2262554" y="4853352"/>
            <a:ext cx="269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5B8CAF6-4AEC-4333-AE27-48754DA404F0}"/>
              </a:ext>
            </a:extLst>
          </p:cNvPr>
          <p:cNvSpPr txBox="1"/>
          <p:nvPr/>
        </p:nvSpPr>
        <p:spPr>
          <a:xfrm>
            <a:off x="2426678" y="4865075"/>
            <a:ext cx="269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D34C954-5222-46D6-9A06-0CDFAA8B5DD8}"/>
              </a:ext>
            </a:extLst>
          </p:cNvPr>
          <p:cNvSpPr txBox="1"/>
          <p:nvPr/>
        </p:nvSpPr>
        <p:spPr>
          <a:xfrm>
            <a:off x="3188677" y="4853352"/>
            <a:ext cx="269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C11B18A-A727-4CF6-B995-66BAC19F591C}"/>
              </a:ext>
            </a:extLst>
          </p:cNvPr>
          <p:cNvSpPr txBox="1"/>
          <p:nvPr/>
        </p:nvSpPr>
        <p:spPr>
          <a:xfrm>
            <a:off x="3352801" y="4865075"/>
            <a:ext cx="269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4D2ECC1-B5DA-4A28-AEE6-88FFF7B62AA9}"/>
              </a:ext>
            </a:extLst>
          </p:cNvPr>
          <p:cNvSpPr txBox="1"/>
          <p:nvPr/>
        </p:nvSpPr>
        <p:spPr>
          <a:xfrm>
            <a:off x="4138246" y="4876798"/>
            <a:ext cx="269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F764406-CFE5-40BE-B81D-4439EFC1A5B9}"/>
              </a:ext>
            </a:extLst>
          </p:cNvPr>
          <p:cNvSpPr txBox="1"/>
          <p:nvPr/>
        </p:nvSpPr>
        <p:spPr>
          <a:xfrm>
            <a:off x="4302370" y="4888521"/>
            <a:ext cx="269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6941BDB-C932-418F-A802-72D4A80270F7}"/>
              </a:ext>
            </a:extLst>
          </p:cNvPr>
          <p:cNvSpPr txBox="1"/>
          <p:nvPr/>
        </p:nvSpPr>
        <p:spPr>
          <a:xfrm>
            <a:off x="5017477" y="4841628"/>
            <a:ext cx="269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56FF723-5F66-4409-9E2E-0088B1681555}"/>
              </a:ext>
            </a:extLst>
          </p:cNvPr>
          <p:cNvSpPr txBox="1"/>
          <p:nvPr/>
        </p:nvSpPr>
        <p:spPr>
          <a:xfrm>
            <a:off x="5181601" y="4853351"/>
            <a:ext cx="269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42950B64-B751-4F57-B901-339B97DC69BE}"/>
              </a:ext>
            </a:extLst>
          </p:cNvPr>
          <p:cNvSpPr/>
          <p:nvPr/>
        </p:nvSpPr>
        <p:spPr>
          <a:xfrm>
            <a:off x="1532791" y="5455983"/>
            <a:ext cx="4399085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800" b="1" kern="10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800" b="1" kern="100" smtClean="0">
                <a:latin typeface="Arial" panose="020B0604020202020204" pitchFamily="34" charset="0"/>
                <a:cs typeface="Arial" panose="020B0604020202020204" pitchFamily="34" charset="0"/>
              </a:rPr>
              <a:t>S2.</a:t>
            </a:r>
            <a:r>
              <a:rPr lang="en-US" altLang="zh-CN" sz="800" kern="10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kern="100" dirty="0">
                <a:latin typeface="Arial" panose="020B0604020202020204" pitchFamily="34" charset="0"/>
                <a:cs typeface="Arial" panose="020B0604020202020204" pitchFamily="34" charset="0"/>
              </a:rPr>
              <a:t>Repeat of experiment in Figure </a:t>
            </a:r>
            <a:r>
              <a:rPr lang="en-US" altLang="zh-CN" sz="8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3B. </a:t>
            </a:r>
            <a:r>
              <a:rPr lang="en-US" altLang="zh-CN" sz="800" kern="100" dirty="0">
                <a:latin typeface="Arial" panose="020B0604020202020204" pitchFamily="34" charset="0"/>
                <a:cs typeface="Arial" panose="020B0604020202020204" pitchFamily="34" charset="0"/>
              </a:rPr>
              <a:t>Glyceollin amounts in W82 soybean hairy roots after 24 h treatment with wall glucan elicitor (WGE) from </a:t>
            </a:r>
            <a:r>
              <a:rPr lang="en-US" altLang="zh-CN" sz="800" i="1" kern="100" dirty="0" err="1">
                <a:latin typeface="Arial" panose="020B0604020202020204" pitchFamily="34" charset="0"/>
                <a:cs typeface="Arial" panose="020B0604020202020204" pitchFamily="34" charset="0"/>
              </a:rPr>
              <a:t>Phytophrhora</a:t>
            </a:r>
            <a:r>
              <a:rPr lang="en-US" altLang="zh-CN" sz="800" i="1" kern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i="1" kern="100" dirty="0" err="1">
                <a:latin typeface="Arial" panose="020B0604020202020204" pitchFamily="34" charset="0"/>
                <a:cs typeface="Arial" panose="020B0604020202020204" pitchFamily="34" charset="0"/>
              </a:rPr>
              <a:t>sojae</a:t>
            </a:r>
            <a:r>
              <a:rPr lang="en-US" altLang="zh-CN" sz="800" i="1" kern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kern="100" dirty="0">
                <a:latin typeface="Arial" panose="020B0604020202020204" pitchFamily="34" charset="0"/>
                <a:cs typeface="Arial" panose="020B0604020202020204" pitchFamily="34" charset="0"/>
              </a:rPr>
              <a:t>and ABA. </a:t>
            </a:r>
            <a:r>
              <a:rPr lang="en-US" altLang="zh-CN" sz="8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 letters show significant differences by single factor ANOVA, Tukey post hoc test, P &lt; 0.05, </a:t>
            </a:r>
            <a:r>
              <a:rPr lang="el-GR" altLang="zh-CN" sz="8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 = 0.05. </a:t>
            </a:r>
            <a:r>
              <a:rPr lang="en-US" altLang="zh-CN" sz="800" kern="100" dirty="0">
                <a:latin typeface="Arial" panose="020B0604020202020204" pitchFamily="34" charset="0"/>
                <a:cs typeface="Arial" panose="020B0604020202020204" pitchFamily="34" charset="0"/>
              </a:rPr>
              <a:t>Error bars = standard error (SE) for three independent biological duplicates (n ≥ 3). For a list of statistical values, see Supplementary Table </a:t>
            </a:r>
            <a:r>
              <a:rPr lang="en-US" altLang="zh-CN" sz="8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S3.</a:t>
            </a:r>
            <a:endParaRPr lang="zh-CN" altLang="zh-CN" sz="800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06686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109</Words>
  <Application>Microsoft Office PowerPoint</Application>
  <PresentationFormat>自定义</PresentationFormat>
  <Paragraphs>1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林 洁</cp:lastModifiedBy>
  <cp:revision>5</cp:revision>
  <dcterms:created xsi:type="dcterms:W3CDTF">2023-08-23T03:17:41Z</dcterms:created>
  <dcterms:modified xsi:type="dcterms:W3CDTF">2024-09-16T20:45:50Z</dcterms:modified>
</cp:coreProperties>
</file>